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56" r:id="rId4"/>
    <p:sldId id="257" r:id="rId5"/>
    <p:sldId id="258" r:id="rId6"/>
    <p:sldId id="259" r:id="rId7"/>
    <p:sldId id="262" r:id="rId8"/>
    <p:sldId id="263" r:id="rId9"/>
  </p:sldIdLst>
  <p:sldSz cx="12192000" cy="6858000"/>
  <p:notesSz cx="6888163" cy="100203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2" autoAdjust="0"/>
    <p:restoredTop sz="94660"/>
  </p:normalViewPr>
  <p:slideViewPr>
    <p:cSldViewPr snapToGrid="0">
      <p:cViewPr varScale="1">
        <p:scale>
          <a:sx n="98" d="100"/>
          <a:sy n="98" d="100"/>
        </p:scale>
        <p:origin x="87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6" Type="http://schemas.openxmlformats.org/officeDocument/2006/relationships/image" Target="../media/image9.emf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image" Target="../media/image10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drawings/_rels/vmlDrawing6.v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image" Target="../media/image15.emf"/></Relationships>
</file>

<file path=ppt/drawings/_rels/vmlDrawing7.vml.rels><?xml version="1.0" encoding="UTF-8" standalone="yes"?>
<Relationships xmlns="http://schemas.openxmlformats.org/package/2006/relationships"><Relationship Id="rId8" Type="http://schemas.openxmlformats.org/officeDocument/2006/relationships/image" Target="../media/image24.emf"/><Relationship Id="rId3" Type="http://schemas.openxmlformats.org/officeDocument/2006/relationships/image" Target="../media/image19.emf"/><Relationship Id="rId7" Type="http://schemas.openxmlformats.org/officeDocument/2006/relationships/image" Target="../media/image23.emf"/><Relationship Id="rId2" Type="http://schemas.openxmlformats.org/officeDocument/2006/relationships/image" Target="../media/image18.emf"/><Relationship Id="rId1" Type="http://schemas.openxmlformats.org/officeDocument/2006/relationships/image" Target="../media/image17.emf"/><Relationship Id="rId6" Type="http://schemas.openxmlformats.org/officeDocument/2006/relationships/image" Target="../media/image22.emf"/><Relationship Id="rId5" Type="http://schemas.openxmlformats.org/officeDocument/2006/relationships/image" Target="../media/image21.emf"/><Relationship Id="rId4" Type="http://schemas.openxmlformats.org/officeDocument/2006/relationships/image" Target="../media/image20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67772D2-46FB-435B-B4DF-12A6AE5714F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D9614B41-D0D9-47C6-B5BE-82EAD2CEC6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12015A9-FD12-4D1C-90C5-35B0BFE702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BB456-B8CB-4C63-9FEC-FC7D4F8C77DA}" type="datetimeFigureOut">
              <a:rPr lang="de-DE" smtClean="0"/>
              <a:t>09.06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6CD0E66-2D36-4E26-AE68-96AE0C7517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3C9B401-8409-414B-A398-77EC7F3C69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C30DE-994D-4B32-A29B-4229DF9FBF6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5034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41604F0-1D3B-4072-834B-39BE125682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1C71CD0-3607-4F6A-B44C-BA5B129F46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9733D3E-4BF0-4465-AB77-63EE41BCA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BB456-B8CB-4C63-9FEC-FC7D4F8C77DA}" type="datetimeFigureOut">
              <a:rPr lang="de-DE" smtClean="0"/>
              <a:t>09.06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403AFAC-015C-4031-90EE-B71FF7053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678437D-E1DB-4B46-9EA4-464C9D07F6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C30DE-994D-4B32-A29B-4229DF9FBF6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4244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B55EF7ED-376A-434B-B68C-360B2588B5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FD99736-65B2-49A6-B707-B0BFFE4ED3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298AF1D-B69C-4E90-8031-1A7188C2B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BB456-B8CB-4C63-9FEC-FC7D4F8C77DA}" type="datetimeFigureOut">
              <a:rPr lang="de-DE" smtClean="0"/>
              <a:t>09.06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352CD9C-0059-4644-8B4B-5B35356D3F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0F0A08C-1169-468A-81F4-7C8FC0E46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C30DE-994D-4B32-A29B-4229DF9FBF6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07780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A70A787-A7D9-4F66-9B82-BE5069DA71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B166023-ADC9-47C7-88E5-7E51179139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FE9C990-1FFC-46A0-B20F-E6356934E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BB456-B8CB-4C63-9FEC-FC7D4F8C77DA}" type="datetimeFigureOut">
              <a:rPr lang="de-DE" smtClean="0"/>
              <a:t>09.06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2376E47-61E3-4332-8F97-7C519A7B6F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4295513-8073-4C87-A186-F339469DA8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C30DE-994D-4B32-A29B-4229DF9FBF6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2867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3EE977A-AA58-4E60-A51B-CCB7B3412A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55A68F5-DFC0-4CF4-84D7-D2E2D29204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58753E5-E0D3-4A11-BD2C-5F6A57D0E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BB456-B8CB-4C63-9FEC-FC7D4F8C77DA}" type="datetimeFigureOut">
              <a:rPr lang="de-DE" smtClean="0"/>
              <a:t>09.06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8CAA735-6FCA-4932-9334-69EFA86B2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334D42B-621D-46B1-BE0E-C339147864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C30DE-994D-4B32-A29B-4229DF9FBF6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243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B3285FE-CA82-438C-902E-22D8AD83A2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508C45B-B362-42E5-BD11-85E1BC1DF5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2BB4C28-DA8A-41E3-8AC0-100E083BB6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CE5330B-4AC0-4793-AF5D-719D90E2D1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BB456-B8CB-4C63-9FEC-FC7D4F8C77DA}" type="datetimeFigureOut">
              <a:rPr lang="de-DE" smtClean="0"/>
              <a:t>09.06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6446795-2DB1-43B4-B2B6-FC85D9A18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D9B4C48-77FB-4A50-BA05-1BF804EACF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C30DE-994D-4B32-A29B-4229DF9FBF6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6498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4313902-B3C4-41A8-9F99-EA9D4659B9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48C194B-6BD0-4F90-891A-2C57432E33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943E0187-91FA-4613-BE7E-3ECD69B270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9567F2B0-C345-42EC-92B0-1158BCA9550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0071C0E3-6C9A-4668-86FD-A0515C5755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4C8DD0CF-803A-4BF1-B066-FD620301F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BB456-B8CB-4C63-9FEC-FC7D4F8C77DA}" type="datetimeFigureOut">
              <a:rPr lang="de-DE" smtClean="0"/>
              <a:t>09.06.2020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12593D55-7C5B-49F2-BD69-C921E93867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170C9DD0-A4DE-44FC-BDF5-030358C37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C30DE-994D-4B32-A29B-4229DF9FBF6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7256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877C18C-F359-43E9-A0D9-E47FB88FBB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7259B33B-E626-4DFF-87D9-D527DD8E0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BB456-B8CB-4C63-9FEC-FC7D4F8C77DA}" type="datetimeFigureOut">
              <a:rPr lang="de-DE" smtClean="0"/>
              <a:t>09.06.2020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A532CEA-6E23-45EF-B7FE-57213BADB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FD9948D8-F5F5-4457-B15B-A0B980448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C30DE-994D-4B32-A29B-4229DF9FBF6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97831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B7B9A71-3EBD-49C9-B0E9-E23DC914B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BB456-B8CB-4C63-9FEC-FC7D4F8C77DA}" type="datetimeFigureOut">
              <a:rPr lang="de-DE" smtClean="0"/>
              <a:t>09.06.2020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8C349C73-3926-4A2C-863A-E032F9CA51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2526A4BF-142E-4159-AF6B-601F16E155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C30DE-994D-4B32-A29B-4229DF9FBF6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5991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1530BE6-99B7-4A21-AF81-B57C553734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2612EC9-2344-41AD-ACDA-53D52215AE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BCBCD1A-3E16-4D1E-A1E6-6D19F3D169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4500C53-9C85-4A64-BBEF-AC32B01F78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BB456-B8CB-4C63-9FEC-FC7D4F8C77DA}" type="datetimeFigureOut">
              <a:rPr lang="de-DE" smtClean="0"/>
              <a:t>09.06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B17389B-303E-4D58-B76E-34CCFF3E1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85478E9-A85E-4C1B-A19A-95AEC9DD95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C30DE-994D-4B32-A29B-4229DF9FBF6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032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76D21ED-4ED8-483F-9A59-CD52127C8D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A33C459-1619-47E8-A021-AB67EB1A96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E468421-A8CD-45A1-889F-D8DB490CBF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84E565C-5CA7-4FFF-A6BF-C0DCBA1C06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BB456-B8CB-4C63-9FEC-FC7D4F8C77DA}" type="datetimeFigureOut">
              <a:rPr lang="de-DE" smtClean="0"/>
              <a:t>09.06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816540F-E6C2-40C9-B49B-3ACDA7FF3D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A952895-C832-417D-A307-87A98F61D5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C30DE-994D-4B32-A29B-4229DF9FBF6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1302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001AC5B8-6EBA-4337-907E-C4112EBD89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8A9B55D-49F5-465B-8FBB-459B5F4D2F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C67101D-9F3A-403D-A915-DC9CC789FC0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BB456-B8CB-4C63-9FEC-FC7D4F8C77DA}" type="datetimeFigureOut">
              <a:rPr lang="de-DE" smtClean="0"/>
              <a:t>09.06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DEEDA36-01D7-4832-94E6-6F4C36BA0C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93B89CC-76AA-41DF-9588-A0A9BFFFFF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AC30DE-994D-4B32-A29B-4229DF9FBF6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3384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oleObject" Target="../embeddings/oleObject9.bin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12" Type="http://schemas.openxmlformats.org/officeDocument/2006/relationships/image" Target="../media/image8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emf"/><Relationship Id="rId11" Type="http://schemas.openxmlformats.org/officeDocument/2006/relationships/oleObject" Target="../embeddings/oleObject8.bin"/><Relationship Id="rId5" Type="http://schemas.openxmlformats.org/officeDocument/2006/relationships/oleObject" Target="../embeddings/oleObject5.bin"/><Relationship Id="rId10" Type="http://schemas.openxmlformats.org/officeDocument/2006/relationships/image" Target="../media/image7.emf"/><Relationship Id="rId4" Type="http://schemas.openxmlformats.org/officeDocument/2006/relationships/image" Target="../media/image4.emf"/><Relationship Id="rId9" Type="http://schemas.openxmlformats.org/officeDocument/2006/relationships/oleObject" Target="../embeddings/oleObject7.bin"/><Relationship Id="rId1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3" Type="http://schemas.openxmlformats.org/officeDocument/2006/relationships/oleObject" Target="../embeddings/oleObject10.bin"/><Relationship Id="rId7" Type="http://schemas.openxmlformats.org/officeDocument/2006/relationships/oleObject" Target="../embeddings/oleObject1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1.emf"/><Relationship Id="rId5" Type="http://schemas.openxmlformats.org/officeDocument/2006/relationships/oleObject" Target="../embeddings/oleObject11.bin"/><Relationship Id="rId4" Type="http://schemas.openxmlformats.org/officeDocument/2006/relationships/image" Target="../media/image10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1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4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14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5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16.emf"/><Relationship Id="rId5" Type="http://schemas.openxmlformats.org/officeDocument/2006/relationships/oleObject" Target="../embeddings/oleObject16.bin"/><Relationship Id="rId4" Type="http://schemas.openxmlformats.org/officeDocument/2006/relationships/image" Target="../media/image15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13" Type="http://schemas.openxmlformats.org/officeDocument/2006/relationships/oleObject" Target="../embeddings/oleObject22.bin"/><Relationship Id="rId18" Type="http://schemas.openxmlformats.org/officeDocument/2006/relationships/image" Target="../media/image24.emf"/><Relationship Id="rId3" Type="http://schemas.openxmlformats.org/officeDocument/2006/relationships/oleObject" Target="../embeddings/oleObject17.bin"/><Relationship Id="rId7" Type="http://schemas.openxmlformats.org/officeDocument/2006/relationships/oleObject" Target="../embeddings/oleObject19.bin"/><Relationship Id="rId12" Type="http://schemas.openxmlformats.org/officeDocument/2006/relationships/image" Target="../media/image21.emf"/><Relationship Id="rId17" Type="http://schemas.openxmlformats.org/officeDocument/2006/relationships/oleObject" Target="../embeddings/oleObject24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23.emf"/><Relationship Id="rId1" Type="http://schemas.openxmlformats.org/officeDocument/2006/relationships/vmlDrawing" Target="../drawings/vmlDrawing7.vml"/><Relationship Id="rId6" Type="http://schemas.openxmlformats.org/officeDocument/2006/relationships/image" Target="../media/image18.emf"/><Relationship Id="rId11" Type="http://schemas.openxmlformats.org/officeDocument/2006/relationships/oleObject" Target="../embeddings/oleObject21.bin"/><Relationship Id="rId5" Type="http://schemas.openxmlformats.org/officeDocument/2006/relationships/oleObject" Target="../embeddings/oleObject18.bin"/><Relationship Id="rId15" Type="http://schemas.openxmlformats.org/officeDocument/2006/relationships/oleObject" Target="../embeddings/oleObject23.bin"/><Relationship Id="rId10" Type="http://schemas.openxmlformats.org/officeDocument/2006/relationships/image" Target="../media/image20.emf"/><Relationship Id="rId4" Type="http://schemas.openxmlformats.org/officeDocument/2006/relationships/image" Target="../media/image17.emf"/><Relationship Id="rId9" Type="http://schemas.openxmlformats.org/officeDocument/2006/relationships/oleObject" Target="../embeddings/oleObject20.bin"/><Relationship Id="rId14" Type="http://schemas.openxmlformats.org/officeDocument/2006/relationships/image" Target="../media/image22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f"/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308CEF9-6392-4316-9DF9-038A5F44A7C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527410" y="132423"/>
          <a:ext cx="3457986" cy="340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24" name="Prism 8" r:id="rId3" imgW="3334136" imgH="3279563" progId="Prism8.Document">
                  <p:embed/>
                </p:oleObj>
              </mc:Choice>
              <mc:Fallback>
                <p:oleObj name="Prism 8" r:id="rId3" imgW="3334136" imgH="3279563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308CEF9-6392-4316-9DF9-038A5F44A7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527410" y="132423"/>
                        <a:ext cx="3457986" cy="340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178EFA3A-4FDF-4907-983F-F983A3E593F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020" y="133319"/>
          <a:ext cx="3828440" cy="33969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25" name="Prism 8" r:id="rId5" imgW="3745772" imgH="3323862" progId="Prism8.Document">
                  <p:embed/>
                </p:oleObj>
              </mc:Choice>
              <mc:Fallback>
                <p:oleObj name="Prism 8" r:id="rId5" imgW="3745772" imgH="3323862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178EFA3A-4FDF-4907-983F-F983A3E593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020" y="133319"/>
                        <a:ext cx="3828440" cy="33969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097B041A-B5E0-477E-9DD0-18B7CCBF746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076637" y="132423"/>
          <a:ext cx="4248596" cy="34001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26" name="Prism 8" r:id="rId7" imgW="4157407" imgH="3326743" progId="Prism8.Document">
                  <p:embed/>
                </p:oleObj>
              </mc:Choice>
              <mc:Fallback>
                <p:oleObj name="Prism 8" r:id="rId7" imgW="4157407" imgH="3326743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097B041A-B5E0-477E-9DD0-18B7CCBF746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076637" y="132423"/>
                        <a:ext cx="4248596" cy="34001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feld 7">
            <a:extLst>
              <a:ext uri="{FF2B5EF4-FFF2-40B4-BE49-F238E27FC236}">
                <a16:creationId xmlns:a16="http://schemas.microsoft.com/office/drawing/2014/main" id="{7C173044-D08B-4E6F-A9BB-9677B49709E7}"/>
              </a:ext>
            </a:extLst>
          </p:cNvPr>
          <p:cNvSpPr txBox="1"/>
          <p:nvPr/>
        </p:nvSpPr>
        <p:spPr>
          <a:xfrm>
            <a:off x="10818661" y="6557918"/>
            <a:ext cx="138691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8BD96D9B-8E6F-4C2D-A0F2-FFF912667C0F}"/>
              </a:ext>
            </a:extLst>
          </p:cNvPr>
          <p:cNvSpPr txBox="1"/>
          <p:nvPr/>
        </p:nvSpPr>
        <p:spPr>
          <a:xfrm>
            <a:off x="0" y="6900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D48F17AF-D86F-4269-8A12-4EFA59F041D8}"/>
              </a:ext>
            </a:extLst>
          </p:cNvPr>
          <p:cNvSpPr txBox="1"/>
          <p:nvPr/>
        </p:nvSpPr>
        <p:spPr>
          <a:xfrm>
            <a:off x="4038677" y="6900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390645FF-8782-44B9-9236-9D10C5AB24C2}"/>
              </a:ext>
            </a:extLst>
          </p:cNvPr>
          <p:cNvSpPr txBox="1"/>
          <p:nvPr/>
        </p:nvSpPr>
        <p:spPr>
          <a:xfrm>
            <a:off x="8414344" y="6900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Rechteck 9">
            <a:extLst>
              <a:ext uri="{FF2B5EF4-FFF2-40B4-BE49-F238E27FC236}">
                <a16:creationId xmlns:a16="http://schemas.microsoft.com/office/drawing/2014/main" id="{E0BDC119-2022-438C-9A6C-07BF16C535E8}"/>
              </a:ext>
            </a:extLst>
          </p:cNvPr>
          <p:cNvSpPr/>
          <p:nvPr/>
        </p:nvSpPr>
        <p:spPr>
          <a:xfrm>
            <a:off x="13579" y="3812762"/>
            <a:ext cx="12192000" cy="8947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ngle sphingolipids identified by LC-HRMS analysis. 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ihydroceramides (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r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18:0), ceramides (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r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18:1) and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phingadiene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ramides (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r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18:2)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Hex2Cer (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actosylceramide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acCer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) and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xCer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lactosylceramide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lCer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/glucosylceramide (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cCer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)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phingomyelin (SM). High values are represented as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ack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middle range values are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d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low values are shown in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hite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ey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quares represent values, which lie under the detection limit. Data are presented as a mean of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=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± SEM. 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49F82B9-4D6B-4708-8FAB-9B05CE5C7ADA}"/>
              </a:ext>
            </a:extLst>
          </p:cNvPr>
          <p:cNvCxnSpPr/>
          <p:nvPr/>
        </p:nvCxnSpPr>
        <p:spPr>
          <a:xfrm>
            <a:off x="117446" y="1073791"/>
            <a:ext cx="28942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12F8F6C1-35CD-42BB-AFC3-261D9B45DE67}"/>
              </a:ext>
            </a:extLst>
          </p:cNvPr>
          <p:cNvCxnSpPr/>
          <p:nvPr/>
        </p:nvCxnSpPr>
        <p:spPr>
          <a:xfrm>
            <a:off x="117446" y="2711042"/>
            <a:ext cx="28942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92433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C906FAA-43B6-408F-BADC-C6DC1D23AC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5397685"/>
              </p:ext>
            </p:extLst>
          </p:nvPr>
        </p:nvGraphicFramePr>
        <p:xfrm>
          <a:off x="2637093" y="6385"/>
          <a:ext cx="3014039" cy="23486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38" name="Prism 8" r:id="rId3" imgW="3745772" imgH="2919769" progId="Prism8.Document">
                  <p:embed/>
                </p:oleObj>
              </mc:Choice>
              <mc:Fallback>
                <p:oleObj name="Prism 8" r:id="rId3" imgW="3745772" imgH="2919769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EC906FAA-43B6-408F-BADC-C6DC1D23AC0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37093" y="6385"/>
                        <a:ext cx="3014039" cy="23486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102FA49-A610-4925-B452-91A8FD2A37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9311757"/>
              </p:ext>
            </p:extLst>
          </p:nvPr>
        </p:nvGraphicFramePr>
        <p:xfrm>
          <a:off x="56194" y="5108"/>
          <a:ext cx="2957845" cy="23499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39" name="Prism 8" r:id="rId5" imgW="3675905" imgH="2921209" progId="Prism8.Document">
                  <p:embed/>
                </p:oleObj>
              </mc:Choice>
              <mc:Fallback>
                <p:oleObj name="Prism 8" r:id="rId5" imgW="3675905" imgH="2921209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7102FA49-A610-4925-B452-91A8FD2A37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6194" y="5108"/>
                        <a:ext cx="2957845" cy="23499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87377B0C-5AAF-4BAE-A0F5-6314139CE1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2365965"/>
              </p:ext>
            </p:extLst>
          </p:nvPr>
        </p:nvGraphicFramePr>
        <p:xfrm>
          <a:off x="5343358" y="0"/>
          <a:ext cx="3014039" cy="2355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40" name="Prism 8" r:id="rId7" imgW="3745772" imgH="2927332" progId="Prism8.Document">
                  <p:embed/>
                </p:oleObj>
              </mc:Choice>
              <mc:Fallback>
                <p:oleObj name="Prism 8" r:id="rId7" imgW="3745772" imgH="2927332" progId="Prism8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87377B0C-5AAF-4BAE-A0F5-6314139CE1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343358" y="0"/>
                        <a:ext cx="3014039" cy="2355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0E38F959-784E-4B5A-8686-B357E2CA61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9070107"/>
              </p:ext>
            </p:extLst>
          </p:nvPr>
        </p:nvGraphicFramePr>
        <p:xfrm>
          <a:off x="0" y="2536735"/>
          <a:ext cx="3014039" cy="23524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41" name="Prism 8" r:id="rId9" imgW="3745772" imgH="2924451" progId="Prism8.Document">
                  <p:embed/>
                </p:oleObj>
              </mc:Choice>
              <mc:Fallback>
                <p:oleObj name="Prism 8" r:id="rId9" imgW="3745772" imgH="2924451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0E38F959-784E-4B5A-8686-B357E2CA61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0" y="2536735"/>
                        <a:ext cx="3014039" cy="23524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AEDF98F9-DF07-4571-900E-32EEB3AA53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5990336"/>
              </p:ext>
            </p:extLst>
          </p:nvPr>
        </p:nvGraphicFramePr>
        <p:xfrm>
          <a:off x="2637093" y="2536735"/>
          <a:ext cx="3014039" cy="23524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42" name="Prism 8" r:id="rId11" imgW="3745772" imgH="2924451" progId="Prism8.Document">
                  <p:embed/>
                </p:oleObj>
              </mc:Choice>
              <mc:Fallback>
                <p:oleObj name="Prism 8" r:id="rId11" imgW="3745772" imgH="2924451" progId="Prism8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AEDF98F9-DF07-4571-900E-32EEB3AA533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637093" y="2536735"/>
                        <a:ext cx="3014039" cy="23524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1B6CA08A-FA1D-48D5-82BF-EC75C03202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601286"/>
              </p:ext>
            </p:extLst>
          </p:nvPr>
        </p:nvGraphicFramePr>
        <p:xfrm>
          <a:off x="5403384" y="2536735"/>
          <a:ext cx="2954013" cy="2355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43" name="Prism 8" r:id="rId13" imgW="3672664" imgH="2927332" progId="Prism8.Document">
                  <p:embed/>
                </p:oleObj>
              </mc:Choice>
              <mc:Fallback>
                <p:oleObj name="Prism 8" r:id="rId13" imgW="3672664" imgH="2927332" progId="Prism8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1B6CA08A-FA1D-48D5-82BF-EC75C03202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403384" y="2536735"/>
                        <a:ext cx="2954013" cy="2355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273ED69D-E28C-474E-A511-ACBEAFD88A49}"/>
              </a:ext>
            </a:extLst>
          </p:cNvPr>
          <p:cNvSpPr txBox="1"/>
          <p:nvPr/>
        </p:nvSpPr>
        <p:spPr>
          <a:xfrm>
            <a:off x="10756992" y="6557918"/>
            <a:ext cx="143500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>
                <a:latin typeface="Arial" panose="020B0604020202020204" pitchFamily="34" charset="0"/>
                <a:cs typeface="Arial" panose="020B0604020202020204" pitchFamily="34" charset="0"/>
              </a:rPr>
              <a:t>Supplemental 1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5CE2BB15-4E3F-4710-9F5C-FEDA4148C539}"/>
              </a:ext>
            </a:extLst>
          </p:cNvPr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Rechteck 17">
            <a:extLst>
              <a:ext uri="{FF2B5EF4-FFF2-40B4-BE49-F238E27FC236}">
                <a16:creationId xmlns:a16="http://schemas.microsoft.com/office/drawing/2014/main" id="{B27FECBF-138F-41E1-B17D-321BD8715256}"/>
              </a:ext>
            </a:extLst>
          </p:cNvPr>
          <p:cNvSpPr/>
          <p:nvPr/>
        </p:nvSpPr>
        <p:spPr>
          <a:xfrm>
            <a:off x="0" y="4854465"/>
            <a:ext cx="12192000" cy="19971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phingolipid species in breast cancer cells following G15 treatment (2.5 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M for 24 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identified by LC-HRMS analysi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dihydroceramid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h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levels. Total of the following analytes: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18:0/22:0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18:0/24:0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18:0/24:1. Total ceramide levels. Total of the following analytes: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18:1/16:0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18:1/18:0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18:1/22:0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18:1/22:1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18:1/23:0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18:1/24:0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18:1/24:1. Total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phingadien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ceramide levels. Total of the following analytes: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18:2/22:0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18:2/24:0. Total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galactosylceramid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al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/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lucosylceramid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lc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levels. Total of the following analytes: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ex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18:1/16:0, 24:0, 24:1. Total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lactosylceramide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ac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levels. Total of the following analytes: Hex2Cer d18:1/16:0, 24:1.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phingomyel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SM) levels. Total of the following analytes: SM 30:1, 32:1, 32:2, 33:1, 34:0, 34:1, 34:2, 36:1, 36:2, 36:3, 37:1, 38:1, 38:2, 40:1, 40:2, 40:3, 41:1, 41:2, 42:1, 42:2, 42:3, 43:1, 43:2. Data are presented as a mean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=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± SEM. Tukey’s multiple comparison test.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**p≤0.01, ***p≤0.001, ****p≤0.0001.Area under curv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AUC)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internal standar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IS)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ot significan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ns).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91584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D279C6B-0237-4560-BBA2-ED32735CA7B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7996186"/>
              </p:ext>
            </p:extLst>
          </p:nvPr>
        </p:nvGraphicFramePr>
        <p:xfrm>
          <a:off x="8131093" y="142676"/>
          <a:ext cx="3343275" cy="332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1" name="Prism 8" r:id="rId3" imgW="3343500" imgH="3326743" progId="Prism8.Document">
                  <p:embed/>
                </p:oleObj>
              </mc:Choice>
              <mc:Fallback>
                <p:oleObj name="Prism 8" r:id="rId3" imgW="3343500" imgH="332674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131093" y="142676"/>
                        <a:ext cx="3343275" cy="332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feld 7">
            <a:extLst>
              <a:ext uri="{FF2B5EF4-FFF2-40B4-BE49-F238E27FC236}">
                <a16:creationId xmlns:a16="http://schemas.microsoft.com/office/drawing/2014/main" id="{7C173044-D08B-4E6F-A9BB-9677B49709E7}"/>
              </a:ext>
            </a:extLst>
          </p:cNvPr>
          <p:cNvSpPr txBox="1"/>
          <p:nvPr/>
        </p:nvSpPr>
        <p:spPr>
          <a:xfrm>
            <a:off x="10818661" y="6542448"/>
            <a:ext cx="138691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8BD96D9B-8E6F-4C2D-A0F2-FFF912667C0F}"/>
              </a:ext>
            </a:extLst>
          </p:cNvPr>
          <p:cNvSpPr txBox="1"/>
          <p:nvPr/>
        </p:nvSpPr>
        <p:spPr>
          <a:xfrm>
            <a:off x="0" y="6900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D48F17AF-D86F-4269-8A12-4EFA59F041D8}"/>
              </a:ext>
            </a:extLst>
          </p:cNvPr>
          <p:cNvSpPr txBox="1"/>
          <p:nvPr/>
        </p:nvSpPr>
        <p:spPr>
          <a:xfrm>
            <a:off x="3992028" y="6900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390645FF-8782-44B9-9236-9D10C5AB24C2}"/>
              </a:ext>
            </a:extLst>
          </p:cNvPr>
          <p:cNvSpPr txBox="1"/>
          <p:nvPr/>
        </p:nvSpPr>
        <p:spPr>
          <a:xfrm>
            <a:off x="8097537" y="7097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8" name="Rechteck 17">
            <a:extLst>
              <a:ext uri="{FF2B5EF4-FFF2-40B4-BE49-F238E27FC236}">
                <a16:creationId xmlns:a16="http://schemas.microsoft.com/office/drawing/2014/main" id="{2178ACC1-B1EE-4376-A3AB-D120D633F436}"/>
              </a:ext>
            </a:extLst>
          </p:cNvPr>
          <p:cNvSpPr/>
          <p:nvPr/>
        </p:nvSpPr>
        <p:spPr>
          <a:xfrm>
            <a:off x="13579" y="3812762"/>
            <a:ext cx="12192000" cy="8947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ngle non-sphingolipid lipids identified by LC-HRMS analysis. 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terol ester (SE)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ther lipids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iglycerides (DG)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iglycerides (TG)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ycerophospholipids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ospholipids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ylcarnitines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High values are represented as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ack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middle range values are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d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low values are shown in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hite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ey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quares represent values, which lie under the detection limit. Data are presented as a mean of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=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± SEM. 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3311D929-2505-42B9-9201-1AD77CA9B3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6586344"/>
              </p:ext>
            </p:extLst>
          </p:nvPr>
        </p:nvGraphicFramePr>
        <p:xfrm>
          <a:off x="349226" y="69003"/>
          <a:ext cx="3525837" cy="3314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2" name="Prism 8" r:id="rId5" imgW="3526449" imgH="3314498" progId="Prism8.Document">
                  <p:embed/>
                </p:oleObj>
              </mc:Choice>
              <mc:Fallback>
                <p:oleObj name="Prism 8" r:id="rId5" imgW="3526449" imgH="331449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9226" y="69003"/>
                        <a:ext cx="3525837" cy="3314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A6D30722-235E-4876-8232-B78FA9F892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7774499"/>
              </p:ext>
            </p:extLst>
          </p:nvPr>
        </p:nvGraphicFramePr>
        <p:xfrm>
          <a:off x="4204704" y="71703"/>
          <a:ext cx="3809749" cy="331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3" name="Prism 8" r:id="rId7" imgW="4775039" imgH="4151496" progId="Prism8.Document">
                  <p:embed/>
                </p:oleObj>
              </mc:Choice>
              <mc:Fallback>
                <p:oleObj name="Prism 8" r:id="rId7" imgW="4775039" imgH="415149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204704" y="71703"/>
                        <a:ext cx="3809749" cy="331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295412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>
            <a:extLst>
              <a:ext uri="{FF2B5EF4-FFF2-40B4-BE49-F238E27FC236}">
                <a16:creationId xmlns:a16="http://schemas.microsoft.com/office/drawing/2014/main" id="{7C173044-D08B-4E6F-A9BB-9677B49709E7}"/>
              </a:ext>
            </a:extLst>
          </p:cNvPr>
          <p:cNvSpPr txBox="1"/>
          <p:nvPr/>
        </p:nvSpPr>
        <p:spPr>
          <a:xfrm>
            <a:off x="10805082" y="6557918"/>
            <a:ext cx="138691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9A3FE313-D247-4CE0-8E4E-4F4DA3F21329}"/>
              </a:ext>
            </a:extLst>
          </p:cNvPr>
          <p:cNvSpPr txBox="1"/>
          <p:nvPr/>
        </p:nvSpPr>
        <p:spPr>
          <a:xfrm>
            <a:off x="104538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A8CFE17-A315-4BF0-85E9-EC5B4854EE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5496601"/>
              </p:ext>
            </p:extLst>
          </p:nvPr>
        </p:nvGraphicFramePr>
        <p:xfrm>
          <a:off x="104537" y="184666"/>
          <a:ext cx="5851645" cy="58414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2" name="Prism 8" r:id="rId3" imgW="5493150" imgH="5482625" progId="Prism8.Document">
                  <p:embed/>
                </p:oleObj>
              </mc:Choice>
              <mc:Fallback>
                <p:oleObj name="Prism 8" r:id="rId3" imgW="5493150" imgH="548262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4537" y="184666"/>
                        <a:ext cx="5851645" cy="58414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553696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>
            <a:extLst>
              <a:ext uri="{FF2B5EF4-FFF2-40B4-BE49-F238E27FC236}">
                <a16:creationId xmlns:a16="http://schemas.microsoft.com/office/drawing/2014/main" id="{7C173044-D08B-4E6F-A9BB-9677B49709E7}"/>
              </a:ext>
            </a:extLst>
          </p:cNvPr>
          <p:cNvSpPr txBox="1"/>
          <p:nvPr/>
        </p:nvSpPr>
        <p:spPr>
          <a:xfrm>
            <a:off x="10805082" y="6557918"/>
            <a:ext cx="138691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9A3FE313-D247-4CE0-8E4E-4F4DA3F21329}"/>
              </a:ext>
            </a:extLst>
          </p:cNvPr>
          <p:cNvSpPr txBox="1"/>
          <p:nvPr/>
        </p:nvSpPr>
        <p:spPr>
          <a:xfrm>
            <a:off x="104538" y="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12F10C1-E936-4FB6-9EBB-9555172C22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5093610"/>
              </p:ext>
            </p:extLst>
          </p:nvPr>
        </p:nvGraphicFramePr>
        <p:xfrm>
          <a:off x="401414" y="-104047"/>
          <a:ext cx="8046300" cy="6974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35" name="Prism 8" r:id="rId3" imgW="7706904" imgH="6680857" progId="Prism8.Document">
                  <p:embed/>
                </p:oleObj>
              </mc:Choice>
              <mc:Fallback>
                <p:oleObj name="Prism 8" r:id="rId3" imgW="7706904" imgH="668085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1414" y="-104047"/>
                        <a:ext cx="8046300" cy="6974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742358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>
            <a:extLst>
              <a:ext uri="{FF2B5EF4-FFF2-40B4-BE49-F238E27FC236}">
                <a16:creationId xmlns:a16="http://schemas.microsoft.com/office/drawing/2014/main" id="{7C173044-D08B-4E6F-A9BB-9677B49709E7}"/>
              </a:ext>
            </a:extLst>
          </p:cNvPr>
          <p:cNvSpPr txBox="1"/>
          <p:nvPr/>
        </p:nvSpPr>
        <p:spPr>
          <a:xfrm>
            <a:off x="10805082" y="6557918"/>
            <a:ext cx="138691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35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350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9A3FE313-D247-4CE0-8E4E-4F4DA3F21329}"/>
              </a:ext>
            </a:extLst>
          </p:cNvPr>
          <p:cNvSpPr txBox="1"/>
          <p:nvPr/>
        </p:nvSpPr>
        <p:spPr>
          <a:xfrm>
            <a:off x="104538" y="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B6B165B-B851-47D2-81A1-97E7301A415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9435060"/>
              </p:ext>
            </p:extLst>
          </p:nvPr>
        </p:nvGraphicFramePr>
        <p:xfrm>
          <a:off x="0" y="184666"/>
          <a:ext cx="5672851" cy="5173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98" name="Prism 8" r:id="rId3" imgW="5515839" imgH="5031352" progId="Prism8.Document">
                  <p:embed/>
                </p:oleObj>
              </mc:Choice>
              <mc:Fallback>
                <p:oleObj name="Prism 8" r:id="rId3" imgW="5515839" imgH="503135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184666"/>
                        <a:ext cx="5672851" cy="5173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CC7B375C-236B-43D8-9084-854989FD89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5321033"/>
              </p:ext>
            </p:extLst>
          </p:nvPr>
        </p:nvGraphicFramePr>
        <p:xfrm>
          <a:off x="6458583" y="184397"/>
          <a:ext cx="4035142" cy="3294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99" name="Prism 8" r:id="rId5" imgW="4075296" imgH="3326743" progId="Prism8.Document">
                  <p:embed/>
                </p:oleObj>
              </mc:Choice>
              <mc:Fallback>
                <p:oleObj name="Prism 8" r:id="rId5" imgW="4075296" imgH="332674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458583" y="184397"/>
                        <a:ext cx="4035142" cy="3294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15">
            <a:extLst>
              <a:ext uri="{FF2B5EF4-FFF2-40B4-BE49-F238E27FC236}">
                <a16:creationId xmlns:a16="http://schemas.microsoft.com/office/drawing/2014/main" id="{CE30425D-7B40-4FE0-A87F-3B1D3CBAD410}"/>
              </a:ext>
            </a:extLst>
          </p:cNvPr>
          <p:cNvSpPr txBox="1"/>
          <p:nvPr/>
        </p:nvSpPr>
        <p:spPr>
          <a:xfrm>
            <a:off x="6458583" y="-269"/>
            <a:ext cx="5752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41821853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5102C449-D72B-4D88-B9BB-1D7CE7DD58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753498"/>
              </p:ext>
            </p:extLst>
          </p:nvPr>
        </p:nvGraphicFramePr>
        <p:xfrm>
          <a:off x="5025815" y="1931347"/>
          <a:ext cx="2626936" cy="2095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26" name="Prism 8" r:id="rId3" imgW="3678786" imgH="2933455" progId="Prism8.Document">
                  <p:embed/>
                </p:oleObj>
              </mc:Choice>
              <mc:Fallback>
                <p:oleObj name="Prism 8" r:id="rId3" imgW="3678786" imgH="2933455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5102C449-D72B-4D88-B9BB-1D7CE7DD58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25815" y="1931347"/>
                        <a:ext cx="2626936" cy="2095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7791425A-2DBA-41CC-B71B-55558DE9C5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655273"/>
              </p:ext>
            </p:extLst>
          </p:nvPr>
        </p:nvGraphicFramePr>
        <p:xfrm>
          <a:off x="2487333" y="1944990"/>
          <a:ext cx="2684746" cy="20936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27" name="Prism 8" r:id="rId5" imgW="3749013" imgH="2924451" progId="Prism8.Document">
                  <p:embed/>
                </p:oleObj>
              </mc:Choice>
              <mc:Fallback>
                <p:oleObj name="Prism 8" r:id="rId5" imgW="3749013" imgH="2924451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7791425A-2DBA-41CC-B71B-55558DE9C5B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487333" y="1944990"/>
                        <a:ext cx="2684746" cy="20936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23B634A2-7B45-4D08-A478-277592E786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8435020"/>
              </p:ext>
            </p:extLst>
          </p:nvPr>
        </p:nvGraphicFramePr>
        <p:xfrm>
          <a:off x="7423922" y="-7960"/>
          <a:ext cx="2629051" cy="20948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28" name="Prism 8" r:id="rId7" imgW="3672664" imgH="2925891" progId="Prism8.Document">
                  <p:embed/>
                </p:oleObj>
              </mc:Choice>
              <mc:Fallback>
                <p:oleObj name="Prism 8" r:id="rId7" imgW="3672664" imgH="2925891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23B634A2-7B45-4D08-A478-277592E786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423922" y="-7960"/>
                        <a:ext cx="2629051" cy="20948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1A1AD324-EFE4-4235-81D3-B70789EAF9E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0" y="0"/>
          <a:ext cx="2734758" cy="20959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29" name="Prism 8" r:id="rId9" imgW="3819239" imgH="2927332" progId="Prism8.Document">
                  <p:embed/>
                </p:oleObj>
              </mc:Choice>
              <mc:Fallback>
                <p:oleObj name="Prism 8" r:id="rId9" imgW="3819239" imgH="2927332" progId="Prism8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1A1AD324-EFE4-4235-81D3-B70789EAF9E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2734758" cy="20959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24E103A0-545D-4D7F-B03E-8CC94FBA0D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9117927"/>
              </p:ext>
            </p:extLst>
          </p:nvPr>
        </p:nvGraphicFramePr>
        <p:xfrm>
          <a:off x="48307" y="1944991"/>
          <a:ext cx="2708616" cy="20936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30" name="Prism 8" r:id="rId11" imgW="3782505" imgH="2924451" progId="Prism8.Document">
                  <p:embed/>
                </p:oleObj>
              </mc:Choice>
              <mc:Fallback>
                <p:oleObj name="Prism 8" r:id="rId11" imgW="3782505" imgH="2924451" progId="Prism8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24E103A0-545D-4D7F-B03E-8CC94FBA0DB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8307" y="1944991"/>
                        <a:ext cx="2708616" cy="20936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979ED7A3-8757-4F5B-892C-AE382E52CE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94108021"/>
              </p:ext>
            </p:extLst>
          </p:nvPr>
        </p:nvGraphicFramePr>
        <p:xfrm>
          <a:off x="7292073" y="1924524"/>
          <a:ext cx="2760900" cy="20914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31" name="Prism 8" r:id="rId13" imgW="3855613" imgH="2921209" progId="Prism8.Document">
                  <p:embed/>
                </p:oleObj>
              </mc:Choice>
              <mc:Fallback>
                <p:oleObj name="Prism 8" r:id="rId13" imgW="3855613" imgH="2921209" progId="Prism8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979ED7A3-8757-4F5B-892C-AE382E52CEC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7292073" y="1924524"/>
                        <a:ext cx="2760900" cy="20914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486598A3-2267-4AC5-A294-1BA904798088}"/>
              </a:ext>
            </a:extLst>
          </p:cNvPr>
          <p:cNvSpPr txBox="1"/>
          <p:nvPr/>
        </p:nvSpPr>
        <p:spPr>
          <a:xfrm>
            <a:off x="10805082" y="6557918"/>
            <a:ext cx="138691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>
                <a:latin typeface="Arial" panose="020B0604020202020204" pitchFamily="34" charset="0"/>
                <a:cs typeface="Arial" panose="020B0604020202020204" pitchFamily="34" charset="0"/>
              </a:rPr>
              <a:t>Supplemental 2</a:t>
            </a:r>
          </a:p>
        </p:txBody>
      </p:sp>
      <p:sp>
        <p:nvSpPr>
          <p:cNvPr id="11" name="Textfeld 15">
            <a:extLst>
              <a:ext uri="{FF2B5EF4-FFF2-40B4-BE49-F238E27FC236}">
                <a16:creationId xmlns:a16="http://schemas.microsoft.com/office/drawing/2014/main" id="{A396E3F2-878A-4AD4-9110-D985C2E584A2}"/>
              </a:ext>
            </a:extLst>
          </p:cNvPr>
          <p:cNvSpPr txBox="1"/>
          <p:nvPr/>
        </p:nvSpPr>
        <p:spPr>
          <a:xfrm>
            <a:off x="-5632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56E9FA1F-7820-475A-A371-AB7653FF3FFF}"/>
              </a:ext>
            </a:extLst>
          </p:cNvPr>
          <p:cNvSpPr/>
          <p:nvPr/>
        </p:nvSpPr>
        <p:spPr>
          <a:xfrm>
            <a:off x="0" y="3807672"/>
            <a:ext cx="12139146" cy="31051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n-sphingolipid species in breast cancer cells following G15 treatment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2.5 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M for 24 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dentified by LC-HRMS analysis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olesterol (ST 27:1_OH). Total sterol ester levels. Total of the following analytes: SE 27:1/14:1, 16:1, 17:1, 18:1, 18:2, 20:3, 20:4, 22:6, 24:1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tal ether lipid levels. Total of the following analytes: LPC O-16:0, 16:1, 18:0, 18:1, PC O-16:0_16:0, 18:2, 20:4, PC O-16:1_16:0, 18:1, 18:2, 20:4, PC O-18:1_20:4, PC O-34:1, PE O-16:1_18:2, 20:4, PE O-18:1_18:1, 18:2, 20:4, LPE O-16:1, 18:1. Total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glyceride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DG) levels. Total of the following analytes: DG 32:1, 32:2, 34:1, 34:2, 34:3, 36:1, 36:2, 36:3, 38:2, 38:5. Total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iglyceride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TG) levels. Total of the following analytes: TG 42:1, 42:2, 43:0, 44:0, 44:1, 44:2, 46:0, 46:1, 46:2, 46:3, 48:0, 48:1, 48:2, 48:3, 48:4, 50:1, 50:2, 50:3, 50:4, 52:1, 52:2, 52:3, 52:4, 52:5, 54:1, 54:2, 54:3, 54:4, 54:5, 54:6, 56:1, 56:2, 56:3, 56:4, 56:6, 58:1, 58:2, 58:3, 58:4, 58:6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tal glycerophospholipids levels. Total of the following analytes: PE 32:1, 34:1, 34:2, 34:3, 36:1, 36:2, 36:3, 36:4, 36:5, 38:4, 38:5, 38:6, 40:6, 40:7, PG 34:1, 36:2, PI 32:1, 34:1, 34:2, 36:1, 36:2, 36:4, 38:4, 38:6, 40:5, 40:6, PS 32:1, 34:1, 34:2, 36:1, 36:2, 38:2, 38:3, PC 30:0, 30:1, 30:2, 32:0, 32:1, 32:2, 33:2, 34:0, 34:1, 34:2, 34:3, 34:4, 34:5, 36:1, 36:2, 36:3, 36:4, 36:5, 38:2, 38:3, 38:4, 38:6, 38:7, 40:6, 40:7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tal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yso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glycerophospholipid levels. Total of the following analytes: LPE 16:0, 18:0, LPG 16:0, 18:1, 18:2, LPI 16:0, 18:0, 18:2, 20:3, 20:4, LPS 18:0, 18:1, LPC 14:0, 15:0, 16:0, 17:0, 18:0, 18:3, 20:0, 20:1, 20:3, 22:0, 24:0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tal acylcarnitine levels. Total of the following analytes: acylcarnitine 14:1, 16:0, 18:0, 18:1. Data are presented as a mean of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=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± SEM. Tukey’s multiple comparison test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p≤0.05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***p≤0.001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****p≤0.0001. Area under curve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AUC),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ternal standard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IS),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t significant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ns).</a:t>
            </a:r>
            <a:endParaRPr lang="en-AU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D6BEE15-1AC1-4415-8406-5A0F42F16E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4942143"/>
              </p:ext>
            </p:extLst>
          </p:nvPr>
        </p:nvGraphicFramePr>
        <p:xfrm>
          <a:off x="2440942" y="-8330"/>
          <a:ext cx="2707626" cy="2095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32" name="Prism 8" r:id="rId15" imgW="3782505" imgH="2927332" progId="Prism8.Document">
                  <p:embed/>
                </p:oleObj>
              </mc:Choice>
              <mc:Fallback>
                <p:oleObj name="Prism 8" r:id="rId15" imgW="3782505" imgH="292733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440942" y="-8330"/>
                        <a:ext cx="2707626" cy="2095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34605D33-99C7-4BB5-AD2B-7069860228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1903294"/>
              </p:ext>
            </p:extLst>
          </p:nvPr>
        </p:nvGraphicFramePr>
        <p:xfrm>
          <a:off x="4969036" y="5313"/>
          <a:ext cx="2686679" cy="2095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33" name="Prism 8" r:id="rId17" imgW="3749013" imgH="2924451" progId="Prism8.Document">
                  <p:embed/>
                </p:oleObj>
              </mc:Choice>
              <mc:Fallback>
                <p:oleObj name="Prism 8" r:id="rId17" imgW="3749013" imgH="292445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969036" y="5313"/>
                        <a:ext cx="2686679" cy="2095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5821641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map&#10;&#10;Description automatically generated">
            <a:extLst>
              <a:ext uri="{FF2B5EF4-FFF2-40B4-BE49-F238E27FC236}">
                <a16:creationId xmlns:a16="http://schemas.microsoft.com/office/drawing/2014/main" id="{236470C4-B3D7-40B1-BD64-88EDE6EDD9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1427" y="160637"/>
            <a:ext cx="5309118" cy="5309118"/>
          </a:xfrm>
          <a:prstGeom prst="rect">
            <a:avLst/>
          </a:prstGeom>
        </p:spPr>
      </p:pic>
      <p:pic>
        <p:nvPicPr>
          <p:cNvPr id="12" name="Picture 11" descr="A picture containing white&#10;&#10;Description automatically generated">
            <a:extLst>
              <a:ext uri="{FF2B5EF4-FFF2-40B4-BE49-F238E27FC236}">
                <a16:creationId xmlns:a16="http://schemas.microsoft.com/office/drawing/2014/main" id="{D0EF46D9-34FC-4790-80DF-A85D198204B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56"/>
          <a:stretch/>
        </p:blipFill>
        <p:spPr>
          <a:xfrm>
            <a:off x="127916" y="369332"/>
            <a:ext cx="5309118" cy="4939786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B07310C4-4CC4-4055-8438-2F6E80F75144}"/>
              </a:ext>
            </a:extLst>
          </p:cNvPr>
          <p:cNvSpPr/>
          <p:nvPr/>
        </p:nvSpPr>
        <p:spPr>
          <a:xfrm>
            <a:off x="0" y="5534728"/>
            <a:ext cx="12192000" cy="11661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AU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ncipal component analysis of breast cancer cell lines</a:t>
            </a:r>
            <a:r>
              <a:rPr lang="en-AU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AU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en-AU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ces between samples are shown in the scores plot with  95% confidence regions. The experiment was repeated three times with three replicates each (n=3). The quality control samples (QC) were pooled from the analysed cell lines MCF-7, SKBr3 and T47D. The variance explained by the principal components are shown in brackets in the axis labels. </a:t>
            </a:r>
            <a:r>
              <a:rPr lang="en-AU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AU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Lipids responsible for the group separations are shown in the loadings plot. The analysis was performed in MetaboAnalyst 4.0 using pareto scaling.</a:t>
            </a:r>
            <a:endParaRPr lang="en-AU" sz="1200" b="0" i="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574F97FF-8D3E-4724-A117-3DB66BF9ABF0}"/>
              </a:ext>
            </a:extLst>
          </p:cNvPr>
          <p:cNvSpPr/>
          <p:nvPr/>
        </p:nvSpPr>
        <p:spPr>
          <a:xfrm>
            <a:off x="223936" y="0"/>
            <a:ext cx="53184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AU" b="0" i="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48A8F173-77CD-4A0F-AB96-153D42A79D80}"/>
              </a:ext>
            </a:extLst>
          </p:cNvPr>
          <p:cNvSpPr/>
          <p:nvPr/>
        </p:nvSpPr>
        <p:spPr>
          <a:xfrm>
            <a:off x="5741427" y="3109"/>
            <a:ext cx="53184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AU" b="0" i="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ED6BC77-A716-4C3E-BB5A-65E4EA7D575F}"/>
              </a:ext>
            </a:extLst>
          </p:cNvPr>
          <p:cNvSpPr txBox="1"/>
          <p:nvPr/>
        </p:nvSpPr>
        <p:spPr>
          <a:xfrm>
            <a:off x="10689666" y="6499451"/>
            <a:ext cx="140615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>
                <a:latin typeface="Arial" panose="020B0604020202020204" pitchFamily="34" charset="0"/>
                <a:cs typeface="Arial" panose="020B0604020202020204" pitchFamily="34" charset="0"/>
              </a:rPr>
              <a:t>Supplemental 3</a:t>
            </a:r>
          </a:p>
        </p:txBody>
      </p:sp>
    </p:spTree>
    <p:extLst>
      <p:ext uri="{BB962C8B-B14F-4D97-AF65-F5344CB8AC3E}">
        <p14:creationId xmlns:p14="http://schemas.microsoft.com/office/powerpoint/2010/main" val="42823742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054</Words>
  <Application>Microsoft Office PowerPoint</Application>
  <PresentationFormat>Widescreen</PresentationFormat>
  <Paragraphs>27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Office</vt:lpstr>
      <vt:lpstr>Prism 8</vt:lpstr>
      <vt:lpstr>GraphPad Prism 8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the-Susanna Wegner</dc:creator>
  <cp:lastModifiedBy>Marthe-Susanna Wegner</cp:lastModifiedBy>
  <cp:revision>59</cp:revision>
  <cp:lastPrinted>2020-03-02T03:45:19Z</cp:lastPrinted>
  <dcterms:created xsi:type="dcterms:W3CDTF">2018-01-24T14:48:38Z</dcterms:created>
  <dcterms:modified xsi:type="dcterms:W3CDTF">2020-06-09T02:19:57Z</dcterms:modified>
</cp:coreProperties>
</file>